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sv-S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0"/>
    <p:restoredTop sz="94659"/>
  </p:normalViewPr>
  <p:slideViewPr>
    <p:cSldViewPr snapToGrid="0" snapToObjects="1">
      <p:cViewPr varScale="1">
        <p:scale>
          <a:sx n="117" d="100"/>
          <a:sy n="117" d="100"/>
        </p:scale>
        <p:origin x="360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F$1</c:f>
                <c:numCache>
                  <c:formatCode>General</c:formatCode>
                  <c:ptCount val="1"/>
                  <c:pt idx="0">
                    <c:v>16.899999999999999</c:v>
                  </c:pt>
                </c:numCache>
              </c:numRef>
            </c:plus>
            <c:minus>
              <c:numRef>
                <c:f>Blad1!$F$2</c:f>
                <c:numCache>
                  <c:formatCode>General</c:formatCode>
                  <c:ptCount val="1"/>
                  <c:pt idx="0">
                    <c:v>14.5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7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065-B647-80BB-D58FF0188AB9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10.6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9.199999999999999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48.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065-B647-80BB-D58FF0188AB9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6.6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6.1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46.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065-B647-80BB-D58FF0188AB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104288"/>
        <c:axId val="306105856"/>
      </c:barChart>
      <c:catAx>
        <c:axId val="3061042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5856"/>
        <c:crosses val="autoZero"/>
        <c:auto val="1"/>
        <c:lblAlgn val="ctr"/>
        <c:lblOffset val="100"/>
        <c:noMultiLvlLbl val="0"/>
      </c:catAx>
      <c:valAx>
        <c:axId val="306105856"/>
        <c:scaling>
          <c:orientation val="minMax"/>
          <c:max val="1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4288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Blad1!$B$1</c:f>
              <c:strCache>
                <c:ptCount val="1"/>
                <c:pt idx="0">
                  <c:v>Serie 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G$1</c:f>
                <c:numCache>
                  <c:formatCode>General</c:formatCode>
                  <c:ptCount val="1"/>
                  <c:pt idx="0">
                    <c:v>14.5</c:v>
                  </c:pt>
                </c:numCache>
              </c:numRef>
            </c:plus>
            <c:minus>
              <c:numRef>
                <c:f>Blad1!$G$2</c:f>
                <c:numCache>
                  <c:formatCode>General</c:formatCode>
                  <c:ptCount val="1"/>
                  <c:pt idx="0">
                    <c:v>12.3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B$2</c:f>
              <c:numCache>
                <c:formatCode>General</c:formatCode>
                <c:ptCount val="1"/>
                <c:pt idx="0">
                  <c:v>60.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7D5-024F-810E-F05B9037C70C}"/>
            </c:ext>
          </c:extLst>
        </c:ser>
        <c:ser>
          <c:idx val="1"/>
          <c:order val="1"/>
          <c:tx>
            <c:strRef>
              <c:f>Blad1!$C$1</c:f>
              <c:strCache>
                <c:ptCount val="1"/>
                <c:pt idx="0">
                  <c:v>Serie 2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H$1</c:f>
                <c:numCache>
                  <c:formatCode>General</c:formatCode>
                  <c:ptCount val="1"/>
                  <c:pt idx="0">
                    <c:v>9.1</c:v>
                  </c:pt>
                </c:numCache>
              </c:numRef>
            </c:plus>
            <c:minus>
              <c:numRef>
                <c:f>Blad1!$H$2</c:f>
                <c:numCache>
                  <c:formatCode>General</c:formatCode>
                  <c:ptCount val="1"/>
                  <c:pt idx="0">
                    <c:v>7.8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C$2</c:f>
              <c:numCache>
                <c:formatCode>General</c:formatCode>
                <c:ptCount val="1"/>
                <c:pt idx="0">
                  <c:v>39.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7D5-024F-810E-F05B9037C70C}"/>
            </c:ext>
          </c:extLst>
        </c:ser>
        <c:ser>
          <c:idx val="2"/>
          <c:order val="2"/>
          <c:tx>
            <c:strRef>
              <c:f>Blad1!$D$1</c:f>
              <c:strCache>
                <c:ptCount val="1"/>
                <c:pt idx="0">
                  <c:v>Serie 3</c:v>
                </c:pt>
              </c:strCache>
            </c:strRef>
          </c:tx>
          <c:spPr>
            <a:solidFill>
              <a:schemeClr val="accent3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Blad1!$I$1</c:f>
                <c:numCache>
                  <c:formatCode>General</c:formatCode>
                  <c:ptCount val="1"/>
                  <c:pt idx="0">
                    <c:v>5.6</c:v>
                  </c:pt>
                </c:numCache>
              </c:numRef>
            </c:plus>
            <c:minus>
              <c:numRef>
                <c:f>Blad1!$I$2</c:f>
                <c:numCache>
                  <c:formatCode>General</c:formatCode>
                  <c:ptCount val="1"/>
                  <c:pt idx="0">
                    <c:v>5.0999999999999996</c:v>
                  </c:pt>
                </c:numCache>
              </c:numRef>
            </c:minus>
            <c:spPr>
              <a:noFill/>
              <a:ln w="1270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Blad1!$A$2</c:f>
              <c:numCache>
                <c:formatCode>General</c:formatCode>
                <c:ptCount val="1"/>
              </c:numCache>
            </c:numRef>
          </c:cat>
          <c:val>
            <c:numRef>
              <c:f>Blad1!$D$2</c:f>
              <c:numCache>
                <c:formatCode>General</c:formatCode>
                <c:ptCount val="1"/>
                <c:pt idx="0">
                  <c:v>36.79999999999999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7D5-024F-810E-F05B9037C70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06109384"/>
        <c:axId val="306106640"/>
      </c:barChart>
      <c:catAx>
        <c:axId val="3061093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6640"/>
        <c:crosses val="autoZero"/>
        <c:auto val="1"/>
        <c:lblAlgn val="ctr"/>
        <c:lblOffset val="100"/>
        <c:noMultiLvlLbl val="0"/>
      </c:catAx>
      <c:valAx>
        <c:axId val="306106640"/>
        <c:scaling>
          <c:orientation val="minMax"/>
          <c:max val="10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bg1"/>
                </a:solidFill>
                <a:latin typeface="+mn-lt"/>
                <a:ea typeface="+mn-ea"/>
                <a:cs typeface="+mn-cs"/>
              </a:defRPr>
            </a:pPr>
            <a:endParaRPr lang="sv-SE"/>
          </a:p>
        </c:txPr>
        <c:crossAx val="306109384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sv-S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33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A96320-9414-324B-95AC-2CC68704EFE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D223BD5-37DF-694E-A4B1-BF0E3154019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931556-31E4-F94E-BAED-F15E6509EF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17F1F00-51A7-614A-A99B-03370DC138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C00979-D233-2544-B9F3-670B388EA3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9860446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7A8EC0D-EB68-4049-950E-503A8B49B9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BD4299F-9BAF-B048-B467-B1DAD39B28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41FE05-D888-DF45-B206-704E27920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B605FE-1BCB-904E-B53C-F84E6F8FC4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BBB9B3-F1ED-5047-B36B-8BA24D317E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0999734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E2022AC-B242-4D44-9B63-47CD6FF2972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33AFA5F-97FD-F34D-AB1E-74AD8EB8C55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0D5D32-1839-AD45-95F3-8C5E56D485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FBD985-F542-8C4A-A529-ABED8F8DE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77AC5D-C7C7-2046-82D4-81D8E79928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06243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833D1C-29E1-6941-B20D-8CF29EB0B8C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1F7E45-B974-C341-8F9C-97E29E3C79D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680E8C-FCAF-154E-8F04-8DC8749D5B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931934-2F10-114C-B4D5-6BCF8DD264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E8E27A2-B84F-5F46-8A9D-F130DE9B3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761621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BE0434-5228-3B48-B937-EED155E4614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128295-6E3E-B24D-B256-473EC0C8CFD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BA8E4C-3957-A449-AA72-49ABC9E265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D4CCBB-273A-BA4A-8BCC-A98C81A5F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E8C128-CA22-214A-B21A-81D45A9A4F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5298790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3169D6-16E4-1F4C-88D4-221C6E2229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C482FF9-2E89-C140-9152-85058E9DD4B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2213DCE-3D94-5F40-8E0C-A9BAEDB9234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C11051E-CE4D-9947-9437-FF2C894B76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802C501-529B-554F-983F-EDCC1FBEF8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FD6CBD-6FCD-D745-B102-55F8831A45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90976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115D1A-AD0A-7D4B-8468-A1E4EC61665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228E46-E94A-4440-B154-AFA26D46BE9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F282E7D-1334-3345-9202-612F22581BB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1F0AA0E-9908-7740-87CA-B70FFAD222C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1355BDC-5F4A-7E46-9A34-9E764CFEFDF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9D231A1-E289-1543-91DB-E4A1CC972C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8180A23-58B5-FE44-A4F1-86FE8B3B4B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C00D542-4F7E-684D-AB3E-EEE07EFF5E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987139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725763-1E07-E740-85BA-267CF257ED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ED3CE77-F5A2-7348-BB57-24C92296E1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C4A0C29-E653-D24C-9544-7607BF693B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B38A5E3-8F6E-9C4B-8F79-7962269131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33944978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A86A53B-B44B-084F-8CDA-1A37493D13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1BC41F2-CF2F-404F-9E8B-B8B124A5E9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2A958F0-E8D5-9E4E-8456-EBA1F4DA1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131170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F2B0F-56E9-F14F-9163-E2AF1C3F40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F2F8A98-E34F-BA41-838A-39811659D0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711CBD-707B-FC49-9123-DA925DC0D00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C98B6-48E1-6545-A352-C433D51120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991DACF-C3E5-D74F-BFCC-6933C88043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985B37-DC59-6F4D-A45C-B20FD3BF95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8210570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0912295-A3D0-264A-801D-206934B400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FA31BA7-B871-404F-A40D-7658ED25A99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v-S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18F053-D80A-8645-A46F-1C327A27661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70DBAA-3DC1-474F-A964-AC255ACE44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31F064D-E918-C540-A38A-0668DBA7A5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1D1FF5-6BC2-1D45-B3C0-24366505DD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8474767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E3F18D8-DE05-2E45-A3B2-830952D1A0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sv-S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9FBDB4-5C6F-FD43-8F17-7CC815AE9A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F9A0F-86A6-BD4C-9FEC-A5FC7C5F9F9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973C29-AE26-6942-B676-7B8D83B9EA5D}" type="datetimeFigureOut">
              <a:rPr lang="sv-SE" smtClean="0"/>
              <a:t>2019-12-09</a:t>
            </a:fld>
            <a:endParaRPr lang="sv-S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17F5EC7-BA94-1E44-8D3F-8793886093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D36E10-7400-2E41-A056-AFAAD0E596B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A38A99-3FCC-5045-9AA7-AC4B901E37D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7711276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Platshållare för innehåll 8"/>
          <p:cNvGraphicFramePr>
            <a:graphicFrameLocks noGrp="1"/>
          </p:cNvGraphicFramePr>
          <p:nvPr>
            <p:ph sz="half" idx="1"/>
            <p:extLst/>
          </p:nvPr>
        </p:nvGraphicFramePr>
        <p:xfrm>
          <a:off x="21526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2" name="Platshållare för innehåll 11"/>
          <p:cNvGraphicFramePr>
            <a:graphicFrameLocks noGrp="1"/>
          </p:cNvGraphicFramePr>
          <p:nvPr>
            <p:ph sz="half" idx="2"/>
            <p:extLst/>
          </p:nvPr>
        </p:nvGraphicFramePr>
        <p:xfrm>
          <a:off x="6153150" y="1825625"/>
          <a:ext cx="3886200" cy="435133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3" name="TextBox 1">
            <a:extLst>
              <a:ext uri="{FF2B5EF4-FFF2-40B4-BE49-F238E27FC236}">
                <a16:creationId xmlns:a16="http://schemas.microsoft.com/office/drawing/2014/main" id="{BBC6F2A3-B042-9E41-9FDE-2935D1BC485A}"/>
              </a:ext>
            </a:extLst>
          </p:cNvPr>
          <p:cNvSpPr txBox="1"/>
          <p:nvPr/>
        </p:nvSpPr>
        <p:spPr>
          <a:xfrm>
            <a:off x="1664614" y="272144"/>
            <a:ext cx="492443" cy="5750930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>
            <a:defPPr>
              <a:defRPr lang="sv-SE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sv-SE" sz="2000" dirty="0"/>
              <a:t>Lundex  EULAR moderate </a:t>
            </a:r>
            <a:r>
              <a:rPr lang="sv-SE" sz="2000" dirty="0" err="1"/>
              <a:t>response</a:t>
            </a:r>
            <a:r>
              <a:rPr lang="sv-SE" sz="2000" dirty="0"/>
              <a:t> : proportions (%)</a:t>
            </a:r>
          </a:p>
        </p:txBody>
      </p:sp>
      <p:sp>
        <p:nvSpPr>
          <p:cNvPr id="14" name="textruta 13"/>
          <p:cNvSpPr txBox="1"/>
          <p:nvPr/>
        </p:nvSpPr>
        <p:spPr>
          <a:xfrm>
            <a:off x="3057969" y="6023072"/>
            <a:ext cx="93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5" name="textruta 14"/>
          <p:cNvSpPr txBox="1"/>
          <p:nvPr/>
        </p:nvSpPr>
        <p:spPr>
          <a:xfrm>
            <a:off x="3847071" y="6023074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16" name="textruta 15"/>
          <p:cNvSpPr txBox="1"/>
          <p:nvPr/>
        </p:nvSpPr>
        <p:spPr>
          <a:xfrm>
            <a:off x="4480212" y="6023072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18" name="textruta 17"/>
          <p:cNvSpPr txBox="1"/>
          <p:nvPr/>
        </p:nvSpPr>
        <p:spPr>
          <a:xfrm>
            <a:off x="6982010" y="6023071"/>
            <a:ext cx="93911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Bionaive</a:t>
            </a:r>
          </a:p>
        </p:txBody>
      </p:sp>
      <p:sp>
        <p:nvSpPr>
          <p:cNvPr id="19" name="textruta 18"/>
          <p:cNvSpPr txBox="1"/>
          <p:nvPr/>
        </p:nvSpPr>
        <p:spPr>
          <a:xfrm>
            <a:off x="7799404" y="6016204"/>
            <a:ext cx="8732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1 </a:t>
            </a:r>
            <a:r>
              <a:rPr lang="sv-SE" sz="1200" dirty="0" err="1"/>
              <a:t>bDMARD</a:t>
            </a:r>
            <a:endParaRPr lang="sv-SE" sz="1200" dirty="0"/>
          </a:p>
        </p:txBody>
      </p:sp>
      <p:sp>
        <p:nvSpPr>
          <p:cNvPr id="20" name="textruta 19"/>
          <p:cNvSpPr txBox="1"/>
          <p:nvPr/>
        </p:nvSpPr>
        <p:spPr>
          <a:xfrm>
            <a:off x="8484831" y="6023072"/>
            <a:ext cx="13056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1200" dirty="0"/>
              <a:t>≥2 </a:t>
            </a:r>
            <a:r>
              <a:rPr lang="sv-SE" sz="1200" dirty="0" err="1"/>
              <a:t>bDMARDs</a:t>
            </a:r>
            <a:endParaRPr lang="sv-SE" sz="1200" dirty="0"/>
          </a:p>
        </p:txBody>
      </p:sp>
      <p:sp>
        <p:nvSpPr>
          <p:cNvPr id="21" name="textruta 20"/>
          <p:cNvSpPr txBox="1"/>
          <p:nvPr/>
        </p:nvSpPr>
        <p:spPr>
          <a:xfrm>
            <a:off x="3533774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6 </a:t>
            </a:r>
            <a:r>
              <a:rPr lang="sv-SE" sz="2000" dirty="0" err="1"/>
              <a:t>months</a:t>
            </a:r>
            <a:endParaRPr lang="sv-SE" sz="2000" dirty="0"/>
          </a:p>
        </p:txBody>
      </p:sp>
      <p:sp>
        <p:nvSpPr>
          <p:cNvPr id="22" name="textruta 21"/>
          <p:cNvSpPr txBox="1"/>
          <p:nvPr/>
        </p:nvSpPr>
        <p:spPr>
          <a:xfrm>
            <a:off x="7337595" y="6367848"/>
            <a:ext cx="151730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sv-SE" sz="2000" dirty="0"/>
              <a:t>12 </a:t>
            </a:r>
            <a:r>
              <a:rPr lang="sv-SE" sz="2000" dirty="0" err="1"/>
              <a:t>months</a:t>
            </a:r>
            <a:endParaRPr lang="sv-SE" sz="2000" dirty="0"/>
          </a:p>
        </p:txBody>
      </p:sp>
    </p:spTree>
    <p:extLst>
      <p:ext uri="{BB962C8B-B14F-4D97-AF65-F5344CB8AC3E}">
        <p14:creationId xmlns:p14="http://schemas.microsoft.com/office/powerpoint/2010/main" val="2256639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8</TotalTime>
  <Words>23</Words>
  <Application>Microsoft Macintosh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iovanni Cagnotto</dc:creator>
  <cp:lastModifiedBy>Giovanni Cagnotto</cp:lastModifiedBy>
  <cp:revision>9</cp:revision>
  <dcterms:created xsi:type="dcterms:W3CDTF">2019-08-15T21:56:58Z</dcterms:created>
  <dcterms:modified xsi:type="dcterms:W3CDTF">2019-12-09T12:09:38Z</dcterms:modified>
</cp:coreProperties>
</file>